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jpeg" ContentType="image/jpeg"/>
  <Override PartName="/ppt/media/image8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937500" cy="114220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938000" cy="11422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440160" cy="57168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497480" y="0"/>
            <a:ext cx="3440160" cy="57168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63400" y="856800"/>
            <a:ext cx="3210120" cy="4280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93440" y="5425560"/>
            <a:ext cx="6351480" cy="513900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10850400"/>
            <a:ext cx="3440160" cy="57024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497480" y="10850400"/>
            <a:ext cx="3440160" cy="570240"/>
          </a:xfrm>
          <a:prstGeom prst="rect">
            <a:avLst/>
          </a:prstGeom>
          <a:noFill/>
          <a:ln w="0">
            <a:noFill/>
          </a:ln>
        </p:spPr>
        <p:txBody>
          <a:bodyPr lIns="106560" rIns="106560" tIns="53280" bIns="53280" anchor="b">
            <a:noAutofit/>
          </a:bodyPr>
          <a:lstStyle>
            <a:lvl1pPr indent="0" algn="r">
              <a:buNone/>
              <a:tabLst>
                <a:tab algn="l" pos="0"/>
                <a:tab algn="l" pos="1066680"/>
                <a:tab algn="l" pos="2133720"/>
                <a:tab algn="l" pos="3200400"/>
                <a:tab algn="l" pos="4267080"/>
                <a:tab algn="l" pos="5334120"/>
                <a:tab algn="l" pos="6400800"/>
                <a:tab algn="l" pos="7467480"/>
                <a:tab algn="l" pos="8534520"/>
                <a:tab algn="l" pos="9601200"/>
                <a:tab algn="l" pos="10667880"/>
              </a:tabLst>
              <a:defRPr b="0" lang="fr-FR" sz="15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066680"/>
                <a:tab algn="l" pos="2133720"/>
                <a:tab algn="l" pos="3200400"/>
                <a:tab algn="l" pos="4267080"/>
                <a:tab algn="l" pos="5334120"/>
                <a:tab algn="l" pos="6400800"/>
                <a:tab algn="l" pos="7467480"/>
                <a:tab algn="l" pos="8534520"/>
                <a:tab algn="l" pos="9601200"/>
                <a:tab algn="l" pos="10667880"/>
              </a:tabLst>
            </a:pPr>
            <a:fld id="{4D1918ED-9A50-4106-997D-B9F15D198CF3}" type="slidenum">
              <a:rPr b="0" lang="fr-FR" sz="15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Rectangle 7"/>
          <p:cNvSpPr/>
          <p:nvPr/>
        </p:nvSpPr>
        <p:spPr>
          <a:xfrm>
            <a:off x="4497480" y="10850400"/>
            <a:ext cx="3440160" cy="57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6560" rIns="106560" tIns="53280" bIns="53280" anchor="b">
            <a:noAutofit/>
          </a:bodyPr>
          <a:p>
            <a:pPr algn="r">
              <a:tabLst>
                <a:tab algn="l" pos="0"/>
                <a:tab algn="l" pos="1066680"/>
                <a:tab algn="l" pos="2133720"/>
                <a:tab algn="l" pos="3200400"/>
                <a:tab algn="l" pos="4267080"/>
                <a:tab algn="l" pos="5334120"/>
                <a:tab algn="l" pos="6400800"/>
                <a:tab algn="l" pos="7467480"/>
                <a:tab algn="l" pos="8534520"/>
                <a:tab algn="l" pos="9601200"/>
                <a:tab algn="l" pos="10667880"/>
              </a:tabLst>
            </a:pPr>
            <a:fld id="{367EBB61-F7ED-4F53-97CE-D7113E1AB04E}" type="slidenum">
              <a:rPr b="0" lang="fr-FR" sz="15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PlaceHolder 1"/>
          <p:cNvSpPr>
            <a:spLocks noGrp="1"/>
          </p:cNvSpPr>
          <p:nvPr>
            <p:ph type="sldImg"/>
          </p:nvPr>
        </p:nvSpPr>
        <p:spPr>
          <a:xfrm>
            <a:off x="2363760" y="857160"/>
            <a:ext cx="3210120" cy="4280040"/>
          </a:xfrm>
          <a:prstGeom prst="rect">
            <a:avLst/>
          </a:prstGeom>
          <a:ln w="0">
            <a:noFill/>
          </a:ln>
        </p:spPr>
      </p:sp>
      <p:sp>
        <p:nvSpPr>
          <p:cNvPr id="300" name="PlaceHolder 2"/>
          <p:cNvSpPr>
            <a:spLocks noGrp="1"/>
          </p:cNvSpPr>
          <p:nvPr>
            <p:ph type="body"/>
          </p:nvPr>
        </p:nvSpPr>
        <p:spPr>
          <a:xfrm>
            <a:off x="793440" y="5425560"/>
            <a:ext cx="6351480" cy="5148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24BDF-8280-47F6-B401-2250941920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2619EA-176A-4306-9F06-08F2D81579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71B4A-824D-4A2F-B12D-3A4F3D54D6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1F2FB-D6BE-4705-B183-77C48316D7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1E779-0638-4F2A-9BF7-CC20839D89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0FC41-06FC-4AE3-88DF-36CC01B4FB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BD7A53-9B25-4103-95AB-E09CC69406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96EF3-CFD8-4D5E-A884-8AEE8A1021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44AC95-AC3B-48F9-A3DA-54702F0117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65C69-B2A7-4669-8829-B3C0945A78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5C62E-4E38-457F-8A45-585D974A81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4D088-FC5F-4D4A-A4F3-9DE33DD1EE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0713E4-7F2E-4744-B1B9-99FB8265AE4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8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311040" y="2498760"/>
            <a:ext cx="2970000" cy="1879920"/>
            <a:chOff x="311040" y="2498760"/>
            <a:chExt cx="2970000" cy="1879920"/>
          </a:xfrm>
        </p:grpSpPr>
        <p:sp>
          <p:nvSpPr>
            <p:cNvPr id="49" name="Rectangle 3"/>
            <p:cNvSpPr/>
            <p:nvPr/>
          </p:nvSpPr>
          <p:spPr>
            <a:xfrm>
              <a:off x="1236600" y="2793960"/>
              <a:ext cx="203040" cy="10954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4"/>
            <p:cNvSpPr/>
            <p:nvPr/>
          </p:nvSpPr>
          <p:spPr>
            <a:xfrm>
              <a:off x="1736640" y="3035520"/>
              <a:ext cx="201600" cy="8539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5"/>
            <p:cNvSpPr/>
            <p:nvPr/>
          </p:nvSpPr>
          <p:spPr>
            <a:xfrm>
              <a:off x="2234880" y="3543480"/>
              <a:ext cx="196920" cy="3459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6"/>
            <p:cNvSpPr/>
            <p:nvPr/>
          </p:nvSpPr>
          <p:spPr>
            <a:xfrm>
              <a:off x="2728800" y="3532320"/>
              <a:ext cx="201600" cy="3571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7"/>
            <p:cNvSpPr/>
            <p:nvPr/>
          </p:nvSpPr>
          <p:spPr>
            <a:xfrm flipV="1">
              <a:off x="1836720" y="2921040"/>
              <a:ext cx="0" cy="114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8"/>
            <p:cNvSpPr/>
            <p:nvPr/>
          </p:nvSpPr>
          <p:spPr>
            <a:xfrm>
              <a:off x="1817640" y="2921040"/>
              <a:ext cx="46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9"/>
            <p:cNvSpPr/>
            <p:nvPr/>
          </p:nvSpPr>
          <p:spPr>
            <a:xfrm flipV="1">
              <a:off x="2330280" y="3438360"/>
              <a:ext cx="0" cy="1047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0"/>
            <p:cNvSpPr/>
            <p:nvPr/>
          </p:nvSpPr>
          <p:spPr>
            <a:xfrm>
              <a:off x="2307960" y="3438720"/>
              <a:ext cx="49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1"/>
            <p:cNvSpPr/>
            <p:nvPr/>
          </p:nvSpPr>
          <p:spPr>
            <a:xfrm flipV="1">
              <a:off x="2827080" y="349704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12"/>
            <p:cNvSpPr/>
            <p:nvPr/>
          </p:nvSpPr>
          <p:spPr>
            <a:xfrm>
              <a:off x="2808000" y="3497400"/>
              <a:ext cx="47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13"/>
            <p:cNvSpPr/>
            <p:nvPr/>
          </p:nvSpPr>
          <p:spPr>
            <a:xfrm>
              <a:off x="1087200" y="2575080"/>
              <a:ext cx="0" cy="1314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14"/>
            <p:cNvSpPr/>
            <p:nvPr/>
          </p:nvSpPr>
          <p:spPr>
            <a:xfrm>
              <a:off x="1044360" y="388944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5"/>
            <p:cNvSpPr/>
            <p:nvPr/>
          </p:nvSpPr>
          <p:spPr>
            <a:xfrm>
              <a:off x="1044360" y="367020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16"/>
            <p:cNvSpPr/>
            <p:nvPr/>
          </p:nvSpPr>
          <p:spPr>
            <a:xfrm>
              <a:off x="1044360" y="345132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7"/>
            <p:cNvSpPr/>
            <p:nvPr/>
          </p:nvSpPr>
          <p:spPr>
            <a:xfrm>
              <a:off x="1044360" y="323208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8"/>
            <p:cNvSpPr/>
            <p:nvPr/>
          </p:nvSpPr>
          <p:spPr>
            <a:xfrm>
              <a:off x="1044360" y="301464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9"/>
            <p:cNvSpPr/>
            <p:nvPr/>
          </p:nvSpPr>
          <p:spPr>
            <a:xfrm>
              <a:off x="1044360" y="279396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0"/>
            <p:cNvSpPr/>
            <p:nvPr/>
          </p:nvSpPr>
          <p:spPr>
            <a:xfrm>
              <a:off x="1044360" y="257508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21"/>
            <p:cNvSpPr/>
            <p:nvPr/>
          </p:nvSpPr>
          <p:spPr>
            <a:xfrm>
              <a:off x="1087200" y="3889440"/>
              <a:ext cx="1990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22"/>
            <p:cNvSpPr/>
            <p:nvPr/>
          </p:nvSpPr>
          <p:spPr>
            <a:xfrm flipV="1">
              <a:off x="1087200" y="388908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23"/>
            <p:cNvSpPr/>
            <p:nvPr/>
          </p:nvSpPr>
          <p:spPr>
            <a:xfrm flipV="1">
              <a:off x="1587240" y="388908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24"/>
            <p:cNvSpPr/>
            <p:nvPr/>
          </p:nvSpPr>
          <p:spPr>
            <a:xfrm flipV="1">
              <a:off x="2085840" y="388908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25"/>
            <p:cNvSpPr/>
            <p:nvPr/>
          </p:nvSpPr>
          <p:spPr>
            <a:xfrm flipV="1">
              <a:off x="2579400" y="388908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26"/>
            <p:cNvSpPr/>
            <p:nvPr/>
          </p:nvSpPr>
          <p:spPr>
            <a:xfrm flipV="1">
              <a:off x="3078000" y="388908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27"/>
            <p:cNvSpPr/>
            <p:nvPr/>
          </p:nvSpPr>
          <p:spPr>
            <a:xfrm rot="16200000">
              <a:off x="-137880" y="3039840"/>
              <a:ext cx="12636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ATM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 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28"/>
            <p:cNvSpPr/>
            <p:nvPr/>
          </p:nvSpPr>
          <p:spPr>
            <a:xfrm>
              <a:off x="910080" y="37972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29"/>
            <p:cNvSpPr/>
            <p:nvPr/>
          </p:nvSpPr>
          <p:spPr>
            <a:xfrm>
              <a:off x="768240" y="35942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0"/>
            <p:cNvSpPr/>
            <p:nvPr/>
          </p:nvSpPr>
          <p:spPr>
            <a:xfrm>
              <a:off x="768240" y="33750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31"/>
            <p:cNvSpPr/>
            <p:nvPr/>
          </p:nvSpPr>
          <p:spPr>
            <a:xfrm>
              <a:off x="768240" y="3156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32"/>
            <p:cNvSpPr/>
            <p:nvPr/>
          </p:nvSpPr>
          <p:spPr>
            <a:xfrm>
              <a:off x="768240" y="2936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33"/>
            <p:cNvSpPr/>
            <p:nvPr/>
          </p:nvSpPr>
          <p:spPr>
            <a:xfrm>
              <a:off x="768240" y="27162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34"/>
            <p:cNvSpPr/>
            <p:nvPr/>
          </p:nvSpPr>
          <p:spPr>
            <a:xfrm>
              <a:off x="768240" y="24987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35"/>
            <p:cNvSpPr/>
            <p:nvPr/>
          </p:nvSpPr>
          <p:spPr>
            <a:xfrm>
              <a:off x="1116000" y="392112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36"/>
            <p:cNvSpPr/>
            <p:nvPr/>
          </p:nvSpPr>
          <p:spPr>
            <a:xfrm>
              <a:off x="1495800" y="392112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37"/>
            <p:cNvSpPr/>
            <p:nvPr/>
          </p:nvSpPr>
          <p:spPr>
            <a:xfrm>
              <a:off x="2073600" y="392112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38"/>
            <p:cNvSpPr/>
            <p:nvPr/>
          </p:nvSpPr>
          <p:spPr>
            <a:xfrm>
              <a:off x="2376360" y="3919680"/>
              <a:ext cx="9046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+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39"/>
            <p:cNvSpPr/>
            <p:nvPr/>
          </p:nvSpPr>
          <p:spPr>
            <a:xfrm>
              <a:off x="651600" y="395460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" name=""/>
          <p:cNvGrpSpPr/>
          <p:nvPr/>
        </p:nvGrpSpPr>
        <p:grpSpPr>
          <a:xfrm>
            <a:off x="298440" y="4379760"/>
            <a:ext cx="2982600" cy="1878120"/>
            <a:chOff x="298440" y="4379760"/>
            <a:chExt cx="2982600" cy="1878120"/>
          </a:xfrm>
        </p:grpSpPr>
        <p:sp>
          <p:nvSpPr>
            <p:cNvPr id="87" name="Rectangle 58"/>
            <p:cNvSpPr/>
            <p:nvPr/>
          </p:nvSpPr>
          <p:spPr>
            <a:xfrm>
              <a:off x="1231560" y="4684320"/>
              <a:ext cx="201600" cy="10810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59"/>
            <p:cNvSpPr/>
            <p:nvPr/>
          </p:nvSpPr>
          <p:spPr>
            <a:xfrm>
              <a:off x="1730160" y="5482800"/>
              <a:ext cx="201600" cy="2826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60"/>
            <p:cNvSpPr/>
            <p:nvPr/>
          </p:nvSpPr>
          <p:spPr>
            <a:xfrm>
              <a:off x="2228760" y="5020920"/>
              <a:ext cx="201600" cy="744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61"/>
            <p:cNvSpPr/>
            <p:nvPr/>
          </p:nvSpPr>
          <p:spPr>
            <a:xfrm>
              <a:off x="2727000" y="5538600"/>
              <a:ext cx="201600" cy="2268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62"/>
            <p:cNvSpPr/>
            <p:nvPr/>
          </p:nvSpPr>
          <p:spPr>
            <a:xfrm flipV="1">
              <a:off x="1831680" y="544752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63"/>
            <p:cNvSpPr/>
            <p:nvPr/>
          </p:nvSpPr>
          <p:spPr>
            <a:xfrm>
              <a:off x="1811160" y="5447880"/>
              <a:ext cx="46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64"/>
            <p:cNvSpPr/>
            <p:nvPr/>
          </p:nvSpPr>
          <p:spPr>
            <a:xfrm flipV="1">
              <a:off x="2328840" y="5000040"/>
              <a:ext cx="0" cy="20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65"/>
            <p:cNvSpPr/>
            <p:nvPr/>
          </p:nvSpPr>
          <p:spPr>
            <a:xfrm>
              <a:off x="2309760" y="5000400"/>
              <a:ext cx="46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66"/>
            <p:cNvSpPr/>
            <p:nvPr/>
          </p:nvSpPr>
          <p:spPr>
            <a:xfrm flipV="1">
              <a:off x="2825640" y="550476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67"/>
            <p:cNvSpPr/>
            <p:nvPr/>
          </p:nvSpPr>
          <p:spPr>
            <a:xfrm>
              <a:off x="2806560" y="5505120"/>
              <a:ext cx="47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68"/>
            <p:cNvSpPr/>
            <p:nvPr/>
          </p:nvSpPr>
          <p:spPr>
            <a:xfrm>
              <a:off x="1083960" y="4470120"/>
              <a:ext cx="0" cy="1295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69"/>
            <p:cNvSpPr/>
            <p:nvPr/>
          </p:nvSpPr>
          <p:spPr>
            <a:xfrm>
              <a:off x="1041120" y="576540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70"/>
            <p:cNvSpPr/>
            <p:nvPr/>
          </p:nvSpPr>
          <p:spPr>
            <a:xfrm>
              <a:off x="1041120" y="555120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71"/>
            <p:cNvSpPr/>
            <p:nvPr/>
          </p:nvSpPr>
          <p:spPr>
            <a:xfrm>
              <a:off x="1041120" y="533700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72"/>
            <p:cNvSpPr/>
            <p:nvPr/>
          </p:nvSpPr>
          <p:spPr>
            <a:xfrm>
              <a:off x="1041120" y="512424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73"/>
            <p:cNvSpPr/>
            <p:nvPr/>
          </p:nvSpPr>
          <p:spPr>
            <a:xfrm>
              <a:off x="1041120" y="489708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74"/>
            <p:cNvSpPr/>
            <p:nvPr/>
          </p:nvSpPr>
          <p:spPr>
            <a:xfrm>
              <a:off x="1041120" y="468432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75"/>
            <p:cNvSpPr/>
            <p:nvPr/>
          </p:nvSpPr>
          <p:spPr>
            <a:xfrm>
              <a:off x="1041120" y="447012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76"/>
            <p:cNvSpPr/>
            <p:nvPr/>
          </p:nvSpPr>
          <p:spPr>
            <a:xfrm>
              <a:off x="1083960" y="5765400"/>
              <a:ext cx="1992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77"/>
            <p:cNvSpPr/>
            <p:nvPr/>
          </p:nvSpPr>
          <p:spPr>
            <a:xfrm flipV="1">
              <a:off x="1083960" y="576504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78"/>
            <p:cNvSpPr/>
            <p:nvPr/>
          </p:nvSpPr>
          <p:spPr>
            <a:xfrm flipV="1">
              <a:off x="1582560" y="576504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79"/>
            <p:cNvSpPr/>
            <p:nvPr/>
          </p:nvSpPr>
          <p:spPr>
            <a:xfrm flipV="1">
              <a:off x="2079360" y="576504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80"/>
            <p:cNvSpPr/>
            <p:nvPr/>
          </p:nvSpPr>
          <p:spPr>
            <a:xfrm flipV="1">
              <a:off x="2577960" y="576504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81"/>
            <p:cNvSpPr/>
            <p:nvPr/>
          </p:nvSpPr>
          <p:spPr>
            <a:xfrm flipV="1">
              <a:off x="3076560" y="5765040"/>
              <a:ext cx="0" cy="33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82"/>
            <p:cNvSpPr/>
            <p:nvPr/>
          </p:nvSpPr>
          <p:spPr>
            <a:xfrm>
              <a:off x="891000" y="56736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83"/>
            <p:cNvSpPr/>
            <p:nvPr/>
          </p:nvSpPr>
          <p:spPr>
            <a:xfrm>
              <a:off x="749160" y="54637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84"/>
            <p:cNvSpPr/>
            <p:nvPr/>
          </p:nvSpPr>
          <p:spPr>
            <a:xfrm>
              <a:off x="749160" y="52462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85"/>
            <p:cNvSpPr/>
            <p:nvPr/>
          </p:nvSpPr>
          <p:spPr>
            <a:xfrm>
              <a:off x="749160" y="50335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86"/>
            <p:cNvSpPr/>
            <p:nvPr/>
          </p:nvSpPr>
          <p:spPr>
            <a:xfrm>
              <a:off x="749160" y="48081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87"/>
            <p:cNvSpPr/>
            <p:nvPr/>
          </p:nvSpPr>
          <p:spPr>
            <a:xfrm>
              <a:off x="749160" y="45954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88"/>
            <p:cNvSpPr/>
            <p:nvPr/>
          </p:nvSpPr>
          <p:spPr>
            <a:xfrm>
              <a:off x="749160" y="43797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89"/>
            <p:cNvSpPr/>
            <p:nvPr/>
          </p:nvSpPr>
          <p:spPr>
            <a:xfrm rot="16200000">
              <a:off x="-138600" y="4932720"/>
              <a:ext cx="123984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p400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 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90"/>
            <p:cNvSpPr/>
            <p:nvPr/>
          </p:nvSpPr>
          <p:spPr>
            <a:xfrm>
              <a:off x="1116000" y="579888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91"/>
            <p:cNvSpPr/>
            <p:nvPr/>
          </p:nvSpPr>
          <p:spPr>
            <a:xfrm>
              <a:off x="1495800" y="579888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92"/>
            <p:cNvSpPr/>
            <p:nvPr/>
          </p:nvSpPr>
          <p:spPr>
            <a:xfrm>
              <a:off x="2073600" y="579888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93"/>
            <p:cNvSpPr/>
            <p:nvPr/>
          </p:nvSpPr>
          <p:spPr>
            <a:xfrm>
              <a:off x="2376360" y="5798880"/>
              <a:ext cx="9046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+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94"/>
            <p:cNvSpPr/>
            <p:nvPr/>
          </p:nvSpPr>
          <p:spPr>
            <a:xfrm>
              <a:off x="651600" y="583380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4" name="Text Box 106"/>
          <p:cNvSpPr/>
          <p:nvPr/>
        </p:nvSpPr>
        <p:spPr>
          <a:xfrm rot="16200000">
            <a:off x="2160360" y="371160"/>
            <a:ext cx="1068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p400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+A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5" name=""/>
          <p:cNvGrpSpPr/>
          <p:nvPr/>
        </p:nvGrpSpPr>
        <p:grpSpPr>
          <a:xfrm>
            <a:off x="636120" y="222120"/>
            <a:ext cx="2124720" cy="2057400"/>
            <a:chOff x="636120" y="222120"/>
            <a:chExt cx="2124720" cy="2057400"/>
          </a:xfrm>
        </p:grpSpPr>
        <p:pic>
          <p:nvPicPr>
            <p:cNvPr id="126" name="Picture 98" descr=""/>
            <p:cNvPicPr/>
            <p:nvPr/>
          </p:nvPicPr>
          <p:blipFill>
            <a:blip r:embed="rId1">
              <a:grayscl/>
            </a:blip>
            <a:srcRect l="0" t="10206" r="0" b="15130"/>
            <a:stretch/>
          </p:blipFill>
          <p:spPr>
            <a:xfrm>
              <a:off x="1577880" y="1101600"/>
              <a:ext cx="1171800" cy="36036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27" name="Picture 99" descr=""/>
            <p:cNvPicPr/>
            <p:nvPr/>
          </p:nvPicPr>
          <p:blipFill>
            <a:blip r:embed="rId2">
              <a:grayscl/>
            </a:blip>
            <a:srcRect l="0" t="0" r="11167" b="34244"/>
            <a:stretch/>
          </p:blipFill>
          <p:spPr>
            <a:xfrm>
              <a:off x="1571760" y="1928880"/>
              <a:ext cx="1177920" cy="3506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28" name="Line 100"/>
            <p:cNvSpPr/>
            <p:nvPr/>
          </p:nvSpPr>
          <p:spPr>
            <a:xfrm>
              <a:off x="1279440" y="1284120"/>
              <a:ext cx="216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101"/>
            <p:cNvSpPr/>
            <p:nvPr/>
          </p:nvSpPr>
          <p:spPr>
            <a:xfrm>
              <a:off x="857880" y="113184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102"/>
            <p:cNvSpPr/>
            <p:nvPr/>
          </p:nvSpPr>
          <p:spPr>
            <a:xfrm rot="16200000">
              <a:off x="1536480" y="78624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103"/>
            <p:cNvSpPr/>
            <p:nvPr/>
          </p:nvSpPr>
          <p:spPr>
            <a:xfrm rot="16200000">
              <a:off x="1701360" y="668520"/>
              <a:ext cx="65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104"/>
            <p:cNvSpPr/>
            <p:nvPr/>
          </p:nvSpPr>
          <p:spPr>
            <a:xfrm>
              <a:off x="1937880" y="222120"/>
              <a:ext cx="61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105"/>
            <p:cNvSpPr/>
            <p:nvPr/>
          </p:nvSpPr>
          <p:spPr>
            <a:xfrm rot="16200000">
              <a:off x="2066760" y="74304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AT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07"/>
            <p:cNvSpPr/>
            <p:nvPr/>
          </p:nvSpPr>
          <p:spPr>
            <a:xfrm>
              <a:off x="1274760" y="2152800"/>
              <a:ext cx="216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 Box 108"/>
            <p:cNvSpPr/>
            <p:nvPr/>
          </p:nvSpPr>
          <p:spPr>
            <a:xfrm>
              <a:off x="636120" y="1998720"/>
              <a:ext cx="72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109"/>
            <p:cNvSpPr/>
            <p:nvPr/>
          </p:nvSpPr>
          <p:spPr>
            <a:xfrm>
              <a:off x="1276200" y="1701720"/>
              <a:ext cx="216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 Box 110"/>
            <p:cNvSpPr/>
            <p:nvPr/>
          </p:nvSpPr>
          <p:spPr>
            <a:xfrm>
              <a:off x="826560" y="1555920"/>
              <a:ext cx="52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p4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8" name="Picture 111" descr=""/>
            <p:cNvPicPr/>
            <p:nvPr/>
          </p:nvPicPr>
          <p:blipFill>
            <a:blip r:embed="rId3"/>
            <a:srcRect l="1875" t="21934" r="3989" b="1396"/>
            <a:stretch/>
          </p:blipFill>
          <p:spPr>
            <a:xfrm>
              <a:off x="1579680" y="1512720"/>
              <a:ext cx="1170000" cy="36036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39" name="Line 112"/>
            <p:cNvSpPr/>
            <p:nvPr/>
          </p:nvSpPr>
          <p:spPr>
            <a:xfrm>
              <a:off x="1679400" y="492120"/>
              <a:ext cx="1081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0" name=""/>
          <p:cNvSpPr/>
          <p:nvPr/>
        </p:nvSpPr>
        <p:spPr>
          <a:xfrm>
            <a:off x="176760" y="2174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745440" y="2174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3745440" y="32274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3" name=""/>
          <p:cNvGrpSpPr/>
          <p:nvPr/>
        </p:nvGrpSpPr>
        <p:grpSpPr>
          <a:xfrm>
            <a:off x="3984480" y="4514760"/>
            <a:ext cx="2577240" cy="1596240"/>
            <a:chOff x="3984480" y="4514760"/>
            <a:chExt cx="2577240" cy="1596240"/>
          </a:xfrm>
        </p:grpSpPr>
        <p:sp>
          <p:nvSpPr>
            <p:cNvPr id="144" name="Line 13"/>
            <p:cNvSpPr/>
            <p:nvPr/>
          </p:nvSpPr>
          <p:spPr>
            <a:xfrm flipH="1">
              <a:off x="4675320" y="5824800"/>
              <a:ext cx="1738080" cy="0"/>
            </a:xfrm>
            <a:prstGeom prst="line">
              <a:avLst/>
            </a:prstGeom>
            <a:ln w="126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4"/>
            <p:cNvSpPr/>
            <p:nvPr/>
          </p:nvSpPr>
          <p:spPr>
            <a:xfrm flipV="1">
              <a:off x="4675320" y="4644000"/>
              <a:ext cx="0" cy="1180440"/>
            </a:xfrm>
            <a:prstGeom prst="line">
              <a:avLst/>
            </a:prstGeom>
            <a:ln w="1260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5"/>
            <p:cNvSpPr/>
            <p:nvPr/>
          </p:nvSpPr>
          <p:spPr>
            <a:xfrm>
              <a:off x="4848120" y="4840200"/>
              <a:ext cx="231840" cy="9846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6"/>
            <p:cNvSpPr/>
            <p:nvPr/>
          </p:nvSpPr>
          <p:spPr>
            <a:xfrm>
              <a:off x="5429160" y="5413320"/>
              <a:ext cx="231840" cy="411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7"/>
            <p:cNvSpPr/>
            <p:nvPr/>
          </p:nvSpPr>
          <p:spPr>
            <a:xfrm>
              <a:off x="6006960" y="5137920"/>
              <a:ext cx="233640" cy="6868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8"/>
            <p:cNvSpPr/>
            <p:nvPr/>
          </p:nvSpPr>
          <p:spPr>
            <a:xfrm flipV="1">
              <a:off x="5545080" y="5294880"/>
              <a:ext cx="0" cy="11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9"/>
            <p:cNvSpPr/>
            <p:nvPr/>
          </p:nvSpPr>
          <p:spPr>
            <a:xfrm>
              <a:off x="5532480" y="5294880"/>
              <a:ext cx="25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20"/>
            <p:cNvSpPr/>
            <p:nvPr/>
          </p:nvSpPr>
          <p:spPr>
            <a:xfrm flipV="1">
              <a:off x="6122880" y="5048640"/>
              <a:ext cx="0" cy="88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21"/>
            <p:cNvSpPr/>
            <p:nvPr/>
          </p:nvSpPr>
          <p:spPr>
            <a:xfrm>
              <a:off x="6111720" y="5049000"/>
              <a:ext cx="25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22"/>
            <p:cNvSpPr/>
            <p:nvPr/>
          </p:nvSpPr>
          <p:spPr>
            <a:xfrm>
              <a:off x="4675320" y="4644360"/>
              <a:ext cx="0" cy="1180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4" name="Group 23"/>
            <p:cNvGrpSpPr/>
            <p:nvPr/>
          </p:nvGrpSpPr>
          <p:grpSpPr>
            <a:xfrm>
              <a:off x="4637160" y="4644360"/>
              <a:ext cx="37800" cy="1180440"/>
              <a:chOff x="4637160" y="4644360"/>
              <a:chExt cx="37800" cy="1180440"/>
            </a:xfrm>
          </p:grpSpPr>
          <p:sp>
            <p:nvSpPr>
              <p:cNvPr id="155" name="Line 24"/>
              <p:cNvSpPr/>
              <p:nvPr/>
            </p:nvSpPr>
            <p:spPr>
              <a:xfrm>
                <a:off x="4637160" y="582480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ine 25"/>
              <p:cNvSpPr/>
              <p:nvPr/>
            </p:nvSpPr>
            <p:spPr>
              <a:xfrm>
                <a:off x="4637160" y="562788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Line 26"/>
              <p:cNvSpPr/>
              <p:nvPr/>
            </p:nvSpPr>
            <p:spPr>
              <a:xfrm>
                <a:off x="4637160" y="543096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27"/>
              <p:cNvSpPr/>
              <p:nvPr/>
            </p:nvSpPr>
            <p:spPr>
              <a:xfrm>
                <a:off x="4637160" y="523404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ine 28"/>
              <p:cNvSpPr/>
              <p:nvPr/>
            </p:nvSpPr>
            <p:spPr>
              <a:xfrm>
                <a:off x="4637160" y="503784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ine 29"/>
              <p:cNvSpPr/>
              <p:nvPr/>
            </p:nvSpPr>
            <p:spPr>
              <a:xfrm>
                <a:off x="4637160" y="484092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ine 30"/>
              <p:cNvSpPr/>
              <p:nvPr/>
            </p:nvSpPr>
            <p:spPr>
              <a:xfrm>
                <a:off x="4637160" y="4644360"/>
                <a:ext cx="37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2" name="Line 31"/>
            <p:cNvSpPr/>
            <p:nvPr/>
          </p:nvSpPr>
          <p:spPr>
            <a:xfrm>
              <a:off x="4675320" y="5824800"/>
              <a:ext cx="1738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32"/>
            <p:cNvSpPr/>
            <p:nvPr/>
          </p:nvSpPr>
          <p:spPr>
            <a:xfrm flipV="1">
              <a:off x="4675320" y="5824800"/>
              <a:ext cx="0" cy="13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33"/>
            <p:cNvSpPr/>
            <p:nvPr/>
          </p:nvSpPr>
          <p:spPr>
            <a:xfrm flipV="1">
              <a:off x="5256360" y="5824800"/>
              <a:ext cx="0" cy="13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34"/>
            <p:cNvSpPr/>
            <p:nvPr/>
          </p:nvSpPr>
          <p:spPr>
            <a:xfrm flipV="1">
              <a:off x="5834160" y="5824800"/>
              <a:ext cx="0" cy="13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35"/>
            <p:cNvSpPr/>
            <p:nvPr/>
          </p:nvSpPr>
          <p:spPr>
            <a:xfrm flipV="1">
              <a:off x="6413400" y="5824800"/>
              <a:ext cx="0" cy="13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120" bIns="-331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 Box 36"/>
            <p:cNvSpPr/>
            <p:nvPr/>
          </p:nvSpPr>
          <p:spPr>
            <a:xfrm>
              <a:off x="4310280" y="4514760"/>
              <a:ext cx="39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 Box 37"/>
            <p:cNvSpPr/>
            <p:nvPr/>
          </p:nvSpPr>
          <p:spPr>
            <a:xfrm>
              <a:off x="4310280" y="4713480"/>
              <a:ext cx="39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 Box 38"/>
            <p:cNvSpPr/>
            <p:nvPr/>
          </p:nvSpPr>
          <p:spPr>
            <a:xfrm>
              <a:off x="4310280" y="4908240"/>
              <a:ext cx="39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 Box 39"/>
            <p:cNvSpPr/>
            <p:nvPr/>
          </p:nvSpPr>
          <p:spPr>
            <a:xfrm>
              <a:off x="4310280" y="5103000"/>
              <a:ext cx="39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 Box 40"/>
            <p:cNvSpPr/>
            <p:nvPr/>
          </p:nvSpPr>
          <p:spPr>
            <a:xfrm>
              <a:off x="4310280" y="5300640"/>
              <a:ext cx="39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 Box 41"/>
            <p:cNvSpPr/>
            <p:nvPr/>
          </p:nvSpPr>
          <p:spPr>
            <a:xfrm>
              <a:off x="4310280" y="5497920"/>
              <a:ext cx="39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42"/>
            <p:cNvSpPr/>
            <p:nvPr/>
          </p:nvSpPr>
          <p:spPr>
            <a:xfrm>
              <a:off x="4422240" y="56844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43"/>
            <p:cNvSpPr/>
            <p:nvPr/>
          </p:nvSpPr>
          <p:spPr>
            <a:xfrm rot="16200000">
              <a:off x="3549600" y="5031360"/>
              <a:ext cx="12348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0" i="1" lang="fr-FR" sz="1200" spc="-1" strike="noStrike">
                  <a:solidFill>
                    <a:srgbClr val="000000"/>
                  </a:solidFill>
                  <a:latin typeface="Arial"/>
                </a:rPr>
                <a:t>H2A.Z</a:t>
              </a: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 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Text Box 44"/>
            <p:cNvSpPr/>
            <p:nvPr/>
          </p:nvSpPr>
          <p:spPr>
            <a:xfrm>
              <a:off x="4780080" y="583452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Text Box 45"/>
            <p:cNvSpPr/>
            <p:nvPr/>
          </p:nvSpPr>
          <p:spPr>
            <a:xfrm>
              <a:off x="5201280" y="5834520"/>
              <a:ext cx="74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H2A.Z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Text Box 46"/>
            <p:cNvSpPr/>
            <p:nvPr/>
          </p:nvSpPr>
          <p:spPr>
            <a:xfrm>
              <a:off x="5812560" y="5834520"/>
              <a:ext cx="74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H2A.Z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47"/>
            <p:cNvSpPr/>
            <p:nvPr/>
          </p:nvSpPr>
          <p:spPr>
            <a:xfrm>
              <a:off x="4257000" y="587484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9" name=""/>
          <p:cNvGrpSpPr/>
          <p:nvPr/>
        </p:nvGrpSpPr>
        <p:grpSpPr>
          <a:xfrm>
            <a:off x="4403880" y="3452760"/>
            <a:ext cx="1922400" cy="988920"/>
            <a:chOff x="4403880" y="3452760"/>
            <a:chExt cx="1922400" cy="988920"/>
          </a:xfrm>
        </p:grpSpPr>
        <p:pic>
          <p:nvPicPr>
            <p:cNvPr id="180" name="Picture 50" descr=""/>
            <p:cNvPicPr/>
            <p:nvPr/>
          </p:nvPicPr>
          <p:blipFill>
            <a:blip r:embed="rId4"/>
            <a:stretch/>
          </p:blipFill>
          <p:spPr>
            <a:xfrm>
              <a:off x="5259240" y="3678120"/>
              <a:ext cx="94464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81" name="Picture 51" descr=""/>
            <p:cNvPicPr/>
            <p:nvPr/>
          </p:nvPicPr>
          <p:blipFill>
            <a:blip r:embed="rId5"/>
            <a:stretch/>
          </p:blipFill>
          <p:spPr>
            <a:xfrm>
              <a:off x="5256360" y="4109760"/>
              <a:ext cx="949320" cy="331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82" name="Text Box 52"/>
            <p:cNvSpPr/>
            <p:nvPr/>
          </p:nvSpPr>
          <p:spPr>
            <a:xfrm>
              <a:off x="4403880" y="3728880"/>
              <a:ext cx="630000" cy="25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9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Lucida Sans Unicode"/>
                </a:rPr>
                <a:t>H2A.Z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Text Box 53"/>
            <p:cNvSpPr/>
            <p:nvPr/>
          </p:nvSpPr>
          <p:spPr>
            <a:xfrm>
              <a:off x="4645080" y="4162320"/>
              <a:ext cx="438120" cy="25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9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Lucida Sans Unicode"/>
                </a:rPr>
                <a:t>H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 Box 54"/>
            <p:cNvSpPr/>
            <p:nvPr/>
          </p:nvSpPr>
          <p:spPr>
            <a:xfrm>
              <a:off x="5270400" y="3452760"/>
              <a:ext cx="425520" cy="25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9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Lucida Sans Unicode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Text Box 55"/>
            <p:cNvSpPr/>
            <p:nvPr/>
          </p:nvSpPr>
          <p:spPr>
            <a:xfrm>
              <a:off x="5657760" y="3452760"/>
              <a:ext cx="668520" cy="25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9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Lucida Sans Unicode"/>
                </a:rPr>
                <a:t>H2A.Z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 Box 56"/>
            <p:cNvSpPr/>
            <p:nvPr/>
          </p:nvSpPr>
          <p:spPr>
            <a:xfrm>
              <a:off x="4664160" y="3452760"/>
              <a:ext cx="734760" cy="25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9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Lucida Sans Unicode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57"/>
            <p:cNvSpPr/>
            <p:nvPr/>
          </p:nvSpPr>
          <p:spPr>
            <a:xfrm>
              <a:off x="4970520" y="3860640"/>
              <a:ext cx="220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58"/>
            <p:cNvSpPr/>
            <p:nvPr/>
          </p:nvSpPr>
          <p:spPr>
            <a:xfrm>
              <a:off x="4970520" y="4300200"/>
              <a:ext cx="220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9" name=""/>
          <p:cNvGrpSpPr/>
          <p:nvPr/>
        </p:nvGrpSpPr>
        <p:grpSpPr>
          <a:xfrm>
            <a:off x="3952800" y="731880"/>
            <a:ext cx="2575080" cy="1886040"/>
            <a:chOff x="3952800" y="731880"/>
            <a:chExt cx="2575080" cy="1886040"/>
          </a:xfrm>
        </p:grpSpPr>
        <p:sp>
          <p:nvSpPr>
            <p:cNvPr id="190" name="Rectangle 4"/>
            <p:cNvSpPr/>
            <p:nvPr/>
          </p:nvSpPr>
          <p:spPr>
            <a:xfrm>
              <a:off x="4911840" y="1042920"/>
              <a:ext cx="177840" cy="11048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5"/>
            <p:cNvSpPr/>
            <p:nvPr/>
          </p:nvSpPr>
          <p:spPr>
            <a:xfrm>
              <a:off x="5365800" y="1797120"/>
              <a:ext cx="177840" cy="3553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6"/>
            <p:cNvSpPr/>
            <p:nvPr/>
          </p:nvSpPr>
          <p:spPr>
            <a:xfrm flipV="1">
              <a:off x="5446800" y="1701360"/>
              <a:ext cx="3240" cy="95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7"/>
            <p:cNvSpPr/>
            <p:nvPr/>
          </p:nvSpPr>
          <p:spPr>
            <a:xfrm>
              <a:off x="5411880" y="1701720"/>
              <a:ext cx="745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8"/>
            <p:cNvSpPr/>
            <p:nvPr/>
          </p:nvSpPr>
          <p:spPr>
            <a:xfrm>
              <a:off x="5792760" y="1722240"/>
              <a:ext cx="176400" cy="430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9"/>
            <p:cNvSpPr/>
            <p:nvPr/>
          </p:nvSpPr>
          <p:spPr>
            <a:xfrm flipV="1">
              <a:off x="5881680" y="1593360"/>
              <a:ext cx="0" cy="128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0"/>
            <p:cNvSpPr/>
            <p:nvPr/>
          </p:nvSpPr>
          <p:spPr>
            <a:xfrm>
              <a:off x="5845320" y="1593720"/>
              <a:ext cx="727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1"/>
            <p:cNvSpPr/>
            <p:nvPr/>
          </p:nvSpPr>
          <p:spPr>
            <a:xfrm>
              <a:off x="6230880" y="1866960"/>
              <a:ext cx="176400" cy="2854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2"/>
            <p:cNvSpPr/>
            <p:nvPr/>
          </p:nvSpPr>
          <p:spPr>
            <a:xfrm flipV="1">
              <a:off x="6316560" y="1782720"/>
              <a:ext cx="3240" cy="8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3"/>
            <p:cNvSpPr/>
            <p:nvPr/>
          </p:nvSpPr>
          <p:spPr>
            <a:xfrm>
              <a:off x="6281640" y="1782720"/>
              <a:ext cx="748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19"/>
            <p:cNvSpPr/>
            <p:nvPr/>
          </p:nvSpPr>
          <p:spPr>
            <a:xfrm flipV="1">
              <a:off x="5226120" y="2157480"/>
              <a:ext cx="1440" cy="5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20"/>
            <p:cNvSpPr/>
            <p:nvPr/>
          </p:nvSpPr>
          <p:spPr>
            <a:xfrm flipV="1">
              <a:off x="5657760" y="2157480"/>
              <a:ext cx="3240" cy="5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21"/>
            <p:cNvSpPr/>
            <p:nvPr/>
          </p:nvSpPr>
          <p:spPr>
            <a:xfrm flipV="1">
              <a:off x="6091200" y="2157480"/>
              <a:ext cx="0" cy="54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22"/>
            <p:cNvSpPr/>
            <p:nvPr/>
          </p:nvSpPr>
          <p:spPr>
            <a:xfrm rot="16200000">
              <a:off x="3483000" y="1283760"/>
              <a:ext cx="13050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elative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p400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23"/>
            <p:cNvSpPr/>
            <p:nvPr/>
          </p:nvSpPr>
          <p:spPr>
            <a:xfrm>
              <a:off x="4493520" y="20462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24"/>
            <p:cNvSpPr/>
            <p:nvPr/>
          </p:nvSpPr>
          <p:spPr>
            <a:xfrm>
              <a:off x="4381560" y="16160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25"/>
            <p:cNvSpPr/>
            <p:nvPr/>
          </p:nvSpPr>
          <p:spPr>
            <a:xfrm>
              <a:off x="4381560" y="1176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26"/>
            <p:cNvSpPr/>
            <p:nvPr/>
          </p:nvSpPr>
          <p:spPr>
            <a:xfrm>
              <a:off x="4381560" y="731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27"/>
            <p:cNvSpPr/>
            <p:nvPr/>
          </p:nvSpPr>
          <p:spPr>
            <a:xfrm rot="19071000">
              <a:off x="4811760" y="2217240"/>
              <a:ext cx="23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28"/>
            <p:cNvSpPr/>
            <p:nvPr/>
          </p:nvSpPr>
          <p:spPr>
            <a:xfrm rot="19071000">
              <a:off x="5104080" y="2295000"/>
              <a:ext cx="4777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400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29"/>
            <p:cNvSpPr/>
            <p:nvPr/>
          </p:nvSpPr>
          <p:spPr>
            <a:xfrm rot="19071000">
              <a:off x="5534280" y="2296800"/>
              <a:ext cx="4777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400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30"/>
            <p:cNvSpPr/>
            <p:nvPr/>
          </p:nvSpPr>
          <p:spPr>
            <a:xfrm rot="19071000">
              <a:off x="5970240" y="2298240"/>
              <a:ext cx="4777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400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31"/>
            <p:cNvSpPr/>
            <p:nvPr/>
          </p:nvSpPr>
          <p:spPr>
            <a:xfrm>
              <a:off x="4683240" y="2152440"/>
              <a:ext cx="1844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14"/>
            <p:cNvSpPr/>
            <p:nvPr/>
          </p:nvSpPr>
          <p:spPr>
            <a:xfrm>
              <a:off x="4630680" y="2152440"/>
              <a:ext cx="50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15"/>
            <p:cNvSpPr/>
            <p:nvPr/>
          </p:nvSpPr>
          <p:spPr>
            <a:xfrm>
              <a:off x="4630680" y="1706400"/>
              <a:ext cx="50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16"/>
            <p:cNvSpPr/>
            <p:nvPr/>
          </p:nvSpPr>
          <p:spPr>
            <a:xfrm>
              <a:off x="4630680" y="1266840"/>
              <a:ext cx="507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17"/>
            <p:cNvSpPr/>
            <p:nvPr/>
          </p:nvSpPr>
          <p:spPr>
            <a:xfrm>
              <a:off x="4630680" y="828720"/>
              <a:ext cx="5076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18"/>
            <p:cNvSpPr/>
            <p:nvPr/>
          </p:nvSpPr>
          <p:spPr>
            <a:xfrm flipV="1">
              <a:off x="4681440" y="2144520"/>
              <a:ext cx="3240" cy="52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32"/>
            <p:cNvSpPr/>
            <p:nvPr/>
          </p:nvSpPr>
          <p:spPr>
            <a:xfrm flipV="1">
              <a:off x="4681440" y="828360"/>
              <a:ext cx="0" cy="1315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4125240" y="2225520"/>
              <a:ext cx="61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0" name=""/>
          <p:cNvGrpSpPr/>
          <p:nvPr/>
        </p:nvGrpSpPr>
        <p:grpSpPr>
          <a:xfrm>
            <a:off x="1703520" y="6832440"/>
            <a:ext cx="1535400" cy="1781640"/>
            <a:chOff x="1703520" y="6832440"/>
            <a:chExt cx="1535400" cy="1781640"/>
          </a:xfrm>
        </p:grpSpPr>
        <p:sp>
          <p:nvSpPr>
            <p:cNvPr id="221" name=""/>
            <p:cNvSpPr/>
            <p:nvPr/>
          </p:nvSpPr>
          <p:spPr>
            <a:xfrm>
              <a:off x="2528640" y="7267680"/>
              <a:ext cx="168120" cy="10998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2939760" y="8180280"/>
              <a:ext cx="169560" cy="187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2611440" y="7267680"/>
              <a:ext cx="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2600280" y="7267680"/>
              <a:ext cx="26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3025440" y="8124840"/>
              <a:ext cx="0" cy="55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3014640" y="8124840"/>
              <a:ext cx="24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2408040" y="8367480"/>
              <a:ext cx="806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2408040" y="7053120"/>
              <a:ext cx="0" cy="1314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2373120" y="8367480"/>
              <a:ext cx="34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2373120" y="8151840"/>
              <a:ext cx="34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2373120" y="7926480"/>
              <a:ext cx="34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2373120" y="7710480"/>
              <a:ext cx="34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2373120" y="7493040"/>
              <a:ext cx="34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2373120" y="7267680"/>
              <a:ext cx="34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373120" y="7053120"/>
              <a:ext cx="34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flipV="1">
              <a:off x="2408040" y="8367480"/>
              <a:ext cx="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flipV="1">
              <a:off x="2820960" y="8367480"/>
              <a:ext cx="0" cy="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2196000" y="82771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2108160" y="80690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2108160" y="78422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2108160" y="76280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2108160" y="74102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2108160" y="7188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2108160" y="69688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2485440" y="8431200"/>
              <a:ext cx="23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2796120" y="8431200"/>
              <a:ext cx="442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Hsp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2003040" y="843120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rot="16200000">
              <a:off x="1007280" y="7528320"/>
              <a:ext cx="175752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Hsp70 m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9" name=""/>
          <p:cNvSpPr/>
          <p:nvPr/>
        </p:nvSpPr>
        <p:spPr>
          <a:xfrm>
            <a:off x="16560" y="65293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0" name=""/>
          <p:cNvGrpSpPr/>
          <p:nvPr/>
        </p:nvGrpSpPr>
        <p:grpSpPr>
          <a:xfrm>
            <a:off x="-49680" y="6778800"/>
            <a:ext cx="1600560" cy="1539360"/>
            <a:chOff x="-49680" y="6778800"/>
            <a:chExt cx="1600560" cy="1539360"/>
          </a:xfrm>
        </p:grpSpPr>
        <p:pic>
          <p:nvPicPr>
            <p:cNvPr id="251" name="" descr=""/>
            <p:cNvPicPr/>
            <p:nvPr/>
          </p:nvPicPr>
          <p:blipFill>
            <a:blip r:embed="rId6">
              <a:grayscl/>
              <a:lum bright="30000"/>
            </a:blip>
            <a:srcRect l="42402" t="12796" r="46603" b="84613"/>
            <a:stretch/>
          </p:blipFill>
          <p:spPr>
            <a:xfrm>
              <a:off x="885960" y="7638840"/>
              <a:ext cx="664920" cy="2919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52" name="" descr=""/>
            <p:cNvPicPr/>
            <p:nvPr/>
          </p:nvPicPr>
          <p:blipFill>
            <a:blip r:embed="rId7"/>
            <a:srcRect l="33063" t="19445" r="56616" b="78300"/>
            <a:stretch/>
          </p:blipFill>
          <p:spPr>
            <a:xfrm>
              <a:off x="885960" y="8026200"/>
              <a:ext cx="664920" cy="2919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53" name="Line 100"/>
            <p:cNvSpPr/>
            <p:nvPr/>
          </p:nvSpPr>
          <p:spPr>
            <a:xfrm>
              <a:off x="631800" y="7789680"/>
              <a:ext cx="198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Text Box 101"/>
            <p:cNvSpPr/>
            <p:nvPr/>
          </p:nvSpPr>
          <p:spPr>
            <a:xfrm>
              <a:off x="52200" y="7646760"/>
              <a:ext cx="62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Hsp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Text Box 102"/>
            <p:cNvSpPr/>
            <p:nvPr/>
          </p:nvSpPr>
          <p:spPr>
            <a:xfrm rot="16200000">
              <a:off x="844200" y="731700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Text Box 104"/>
            <p:cNvSpPr/>
            <p:nvPr/>
          </p:nvSpPr>
          <p:spPr>
            <a:xfrm>
              <a:off x="933120" y="6778800"/>
              <a:ext cx="61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Text Box 105"/>
            <p:cNvSpPr/>
            <p:nvPr/>
          </p:nvSpPr>
          <p:spPr>
            <a:xfrm rot="16200000">
              <a:off x="1076040" y="7214760"/>
              <a:ext cx="62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Hsp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112"/>
            <p:cNvSpPr/>
            <p:nvPr/>
          </p:nvSpPr>
          <p:spPr>
            <a:xfrm>
              <a:off x="923760" y="7048440"/>
              <a:ext cx="590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100"/>
            <p:cNvSpPr/>
            <p:nvPr/>
          </p:nvSpPr>
          <p:spPr>
            <a:xfrm>
              <a:off x="631800" y="8157960"/>
              <a:ext cx="198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Text Box 101"/>
            <p:cNvSpPr/>
            <p:nvPr/>
          </p:nvSpPr>
          <p:spPr>
            <a:xfrm>
              <a:off x="-49680" y="8015040"/>
              <a:ext cx="72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1" name=""/>
          <p:cNvGrpSpPr/>
          <p:nvPr/>
        </p:nvGrpSpPr>
        <p:grpSpPr>
          <a:xfrm>
            <a:off x="5106960" y="6816600"/>
            <a:ext cx="1596240" cy="1635480"/>
            <a:chOff x="5106960" y="6816600"/>
            <a:chExt cx="1596240" cy="1635480"/>
          </a:xfrm>
        </p:grpSpPr>
        <p:sp>
          <p:nvSpPr>
            <p:cNvPr id="262" name=""/>
            <p:cNvSpPr/>
            <p:nvPr/>
          </p:nvSpPr>
          <p:spPr>
            <a:xfrm>
              <a:off x="5934240" y="7404120"/>
              <a:ext cx="168120" cy="7984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6353280" y="7767720"/>
              <a:ext cx="166680" cy="4348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6018120" y="74041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6005520" y="7404120"/>
              <a:ext cx="2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 flipV="1">
              <a:off x="6434280" y="7689240"/>
              <a:ext cx="0" cy="78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6423120" y="7689600"/>
              <a:ext cx="27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5808600" y="8202600"/>
              <a:ext cx="811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5808600" y="6926040"/>
              <a:ext cx="0" cy="1276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5778720" y="8202600"/>
              <a:ext cx="29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5778720" y="7881840"/>
              <a:ext cx="29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5778720" y="7567560"/>
              <a:ext cx="29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5778720" y="7246800"/>
              <a:ext cx="29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 flipV="1">
              <a:off x="5808600" y="820224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 flipV="1">
              <a:off x="6228000" y="820224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5637960" y="80787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5510520" y="77724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5510520" y="74595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5510520" y="71388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5510520" y="68166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1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5897520" y="8267760"/>
              <a:ext cx="23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6185880" y="8267760"/>
              <a:ext cx="517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FANC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5420520" y="8269200"/>
              <a:ext cx="432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 rot="16200000">
              <a:off x="4674240" y="7380720"/>
              <a:ext cx="123048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Relative FANC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mRNA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5778720" y="6918120"/>
              <a:ext cx="29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6" name=""/>
          <p:cNvSpPr/>
          <p:nvPr/>
        </p:nvSpPr>
        <p:spPr>
          <a:xfrm>
            <a:off x="3322800" y="65293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7" name=""/>
          <p:cNvGrpSpPr/>
          <p:nvPr/>
        </p:nvGrpSpPr>
        <p:grpSpPr>
          <a:xfrm>
            <a:off x="3352680" y="6762600"/>
            <a:ext cx="1609920" cy="1634040"/>
            <a:chOff x="3352680" y="6762600"/>
            <a:chExt cx="1609920" cy="1634040"/>
          </a:xfrm>
        </p:grpSpPr>
        <p:sp>
          <p:nvSpPr>
            <p:cNvPr id="288" name="Line 100"/>
            <p:cNvSpPr/>
            <p:nvPr/>
          </p:nvSpPr>
          <p:spPr>
            <a:xfrm>
              <a:off x="4043520" y="7894440"/>
              <a:ext cx="198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Text Box 101"/>
            <p:cNvSpPr/>
            <p:nvPr/>
          </p:nvSpPr>
          <p:spPr>
            <a:xfrm>
              <a:off x="3352680" y="7751520"/>
              <a:ext cx="74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FANC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Text Box 102"/>
            <p:cNvSpPr/>
            <p:nvPr/>
          </p:nvSpPr>
          <p:spPr>
            <a:xfrm rot="16200000">
              <a:off x="4257360" y="7422120"/>
              <a:ext cx="41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Ctr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Text Box 104"/>
            <p:cNvSpPr/>
            <p:nvPr/>
          </p:nvSpPr>
          <p:spPr>
            <a:xfrm>
              <a:off x="4344480" y="6762600"/>
              <a:ext cx="61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Text Box 105"/>
            <p:cNvSpPr/>
            <p:nvPr/>
          </p:nvSpPr>
          <p:spPr>
            <a:xfrm rot="16200000">
              <a:off x="4429080" y="7259400"/>
              <a:ext cx="74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FANC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112"/>
            <p:cNvSpPr/>
            <p:nvPr/>
          </p:nvSpPr>
          <p:spPr>
            <a:xfrm>
              <a:off x="4335480" y="7032600"/>
              <a:ext cx="590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94" name="" descr=""/>
            <p:cNvPicPr/>
            <p:nvPr/>
          </p:nvPicPr>
          <p:blipFill>
            <a:blip r:embed="rId8"/>
            <a:srcRect l="27518" t="28124" r="63549" b="69289"/>
            <a:stretch/>
          </p:blipFill>
          <p:spPr>
            <a:xfrm>
              <a:off x="4295880" y="8099280"/>
              <a:ext cx="666720" cy="2890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95" name="Line 100"/>
            <p:cNvSpPr/>
            <p:nvPr/>
          </p:nvSpPr>
          <p:spPr>
            <a:xfrm>
              <a:off x="4037040" y="8262720"/>
              <a:ext cx="198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Text Box 101"/>
            <p:cNvSpPr/>
            <p:nvPr/>
          </p:nvSpPr>
          <p:spPr>
            <a:xfrm>
              <a:off x="3369960" y="8120160"/>
              <a:ext cx="72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97" name="" descr=""/>
            <p:cNvPicPr/>
            <p:nvPr/>
          </p:nvPicPr>
          <p:blipFill>
            <a:blip r:embed="rId9"/>
            <a:srcRect l="29552" t="65458" r="62533" b="32068"/>
            <a:stretch/>
          </p:blipFill>
          <p:spPr>
            <a:xfrm>
              <a:off x="4295880" y="7743600"/>
              <a:ext cx="666720" cy="2890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09T13:57:35Z</dcterms:created>
  <dc:creator>stouflette moumoute</dc:creator>
  <dc:description/>
  <dc:language>en-US</dc:language>
  <cp:lastModifiedBy>escaffit</cp:lastModifiedBy>
  <cp:lastPrinted>2009-07-21T09:02:30Z</cp:lastPrinted>
  <dcterms:modified xsi:type="dcterms:W3CDTF">2010-04-08T08:56:53Z</dcterms:modified>
  <cp:revision>112</cp:revision>
  <dc:subject/>
  <dc:title>PowerPoint Presentation</dc:title>
</cp:coreProperties>
</file>